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9137B9B-3419-23A0-D7F9-F8273DDB65D1}" name="jithu.varghese@hotmail.com" initials="j" userId="deb40c3e12d87879" providerId="Windows Live"/>
  <p188:author id="{7ADA9FDE-F161-B09C-2D93-0E3F58F3FB19}" name="Joe Varghese" initials="JV" userId="Joe Varghese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65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426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931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415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879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983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98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575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2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42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650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959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12479-E22D-4ECC-A39A-CC928B494712}" type="datetimeFigureOut">
              <a:rPr lang="en-US" smtClean="0"/>
              <a:t>10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130894-DEB2-48D7-AF1D-B540D4FE64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99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9E11E9F8-1CEE-1E25-7575-490B4DDA14C9}"/>
              </a:ext>
            </a:extLst>
          </p:cNvPr>
          <p:cNvGrpSpPr/>
          <p:nvPr/>
        </p:nvGrpSpPr>
        <p:grpSpPr>
          <a:xfrm>
            <a:off x="175794" y="0"/>
            <a:ext cx="11480669" cy="8122315"/>
            <a:chOff x="711331" y="373660"/>
            <a:chExt cx="11480669" cy="812231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2C1B8EE-A103-9692-F61A-1EF70C79F641}"/>
                </a:ext>
              </a:extLst>
            </p:cNvPr>
            <p:cNvSpPr txBox="1"/>
            <p:nvPr/>
          </p:nvSpPr>
          <p:spPr>
            <a:xfrm>
              <a:off x="912909" y="373660"/>
              <a:ext cx="16424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</a:t>
              </a:r>
              <a:r>
                <a: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gure 5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06468C8-CCD5-B34F-C928-E32218F67D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38539"/>
            <a:stretch/>
          </p:blipFill>
          <p:spPr>
            <a:xfrm>
              <a:off x="887020" y="925377"/>
              <a:ext cx="2548389" cy="3388880"/>
            </a:xfrm>
            <a:prstGeom prst="rect">
              <a:avLst/>
            </a:prstGeom>
          </p:spPr>
        </p:pic>
        <p:graphicFrame>
          <p:nvGraphicFramePr>
            <p:cNvPr id="23" name="Object 22">
              <a:extLst>
                <a:ext uri="{FF2B5EF4-FFF2-40B4-BE49-F238E27FC236}">
                  <a16:creationId xmlns:a16="http://schemas.microsoft.com/office/drawing/2014/main" id="{A99E3996-FA97-A2E2-418E-A3702746E32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22545600"/>
                </p:ext>
              </p:extLst>
            </p:nvPr>
          </p:nvGraphicFramePr>
          <p:xfrm>
            <a:off x="4072891" y="1117760"/>
            <a:ext cx="3343011" cy="32342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2538597" imgH="2455521" progId="Prism10.Document">
                    <p:embed/>
                  </p:oleObj>
                </mc:Choice>
                <mc:Fallback>
                  <p:oleObj name="Prism 10" r:id="rId3" imgW="2538597" imgH="2455521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FE61A68E-961F-7CF8-6D6F-04C11FD7856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072891" y="1117760"/>
                          <a:ext cx="3343011" cy="32342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Object 23">
              <a:extLst>
                <a:ext uri="{FF2B5EF4-FFF2-40B4-BE49-F238E27FC236}">
                  <a16:creationId xmlns:a16="http://schemas.microsoft.com/office/drawing/2014/main" id="{9792B532-07F0-07FA-3815-E6D117CE07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4507858"/>
                </p:ext>
              </p:extLst>
            </p:nvPr>
          </p:nvGraphicFramePr>
          <p:xfrm>
            <a:off x="7731399" y="988817"/>
            <a:ext cx="4460601" cy="34921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3137502" imgH="2455521" progId="Prism10.Document">
                    <p:embed/>
                  </p:oleObj>
                </mc:Choice>
                <mc:Fallback>
                  <p:oleObj name="Prism 10" r:id="rId5" imgW="3137502" imgH="2455521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D7F8E98E-75CB-4791-6832-05AB404388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731399" y="988817"/>
                          <a:ext cx="4460601" cy="34921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CF59431D-D2ED-2CA6-7600-375B76F2D5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6226533"/>
                </p:ext>
              </p:extLst>
            </p:nvPr>
          </p:nvGraphicFramePr>
          <p:xfrm>
            <a:off x="3190332" y="4724261"/>
            <a:ext cx="6210041" cy="37717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3970136" imgH="2411236" progId="Prism10.Document">
                    <p:embed/>
                  </p:oleObj>
                </mc:Choice>
                <mc:Fallback>
                  <p:oleObj name="Prism 10" r:id="rId7" imgW="3970136" imgH="2411236" progId="Prism10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136DAF70-7A1E-3EF2-543A-E29EBB575BF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190332" y="4724261"/>
                          <a:ext cx="6210041" cy="37717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B78A5CA-1CDF-72EA-0E7D-44C3EECE1A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997" b="73814"/>
            <a:stretch/>
          </p:blipFill>
          <p:spPr>
            <a:xfrm>
              <a:off x="6508532" y="828499"/>
              <a:ext cx="1528273" cy="883931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3C1B500-A93F-93F9-9580-B1AA169F98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2997" b="73814"/>
            <a:stretch/>
          </p:blipFill>
          <p:spPr>
            <a:xfrm>
              <a:off x="4980259" y="4885156"/>
              <a:ext cx="1528273" cy="883931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4E81EED-043C-1A0D-B616-219E98B00AF9}"/>
                </a:ext>
              </a:extLst>
            </p:cNvPr>
            <p:cNvSpPr txBox="1"/>
            <p:nvPr/>
          </p:nvSpPr>
          <p:spPr>
            <a:xfrm>
              <a:off x="711331" y="93309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56F214B-EF00-9B29-E1A2-8DB78420333A}"/>
                </a:ext>
              </a:extLst>
            </p:cNvPr>
            <p:cNvSpPr txBox="1"/>
            <p:nvPr/>
          </p:nvSpPr>
          <p:spPr>
            <a:xfrm>
              <a:off x="3897826" y="1022092"/>
              <a:ext cx="3385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747FB7-877A-30FB-60EF-97CCDDB144AE}"/>
                </a:ext>
              </a:extLst>
            </p:cNvPr>
            <p:cNvSpPr txBox="1"/>
            <p:nvPr/>
          </p:nvSpPr>
          <p:spPr>
            <a:xfrm>
              <a:off x="8176612" y="1022092"/>
              <a:ext cx="3513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8BEFFD9-29FB-01FC-626A-A0DE280C6EAD}"/>
                </a:ext>
              </a:extLst>
            </p:cNvPr>
            <p:cNvSpPr txBox="1"/>
            <p:nvPr/>
          </p:nvSpPr>
          <p:spPr>
            <a:xfrm>
              <a:off x="3891414" y="4470939"/>
              <a:ext cx="3513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33B295DC-7585-8C1C-B298-1EA9CD05D3F5}"/>
              </a:ext>
            </a:extLst>
          </p:cNvPr>
          <p:cNvSpPr txBox="1"/>
          <p:nvPr/>
        </p:nvSpPr>
        <p:spPr>
          <a:xfrm>
            <a:off x="175794" y="7943671"/>
            <a:ext cx="1194214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 Figure 5</a:t>
            </a:r>
            <a:r>
              <a:rPr lang="en-US" dirty="0"/>
              <a:t>: Baseline data in WT and Hamp1-/- mice</a:t>
            </a:r>
          </a:p>
          <a:p>
            <a:r>
              <a:rPr lang="en-US" dirty="0"/>
              <a:t>Hemoglobin (A) and total erythroid cells (Ter119+ cells) in bone marrow (B) in wild-type and Hamp1-/- mice aged 8 weeks (prior to starting CD/HFD feeding). (C) and (D) show proportions of erythroid precursors in bone marrow based on CD71 expression (C) and CD44 expression (D), respectively. </a:t>
            </a:r>
          </a:p>
        </p:txBody>
      </p:sp>
    </p:spTree>
    <p:extLst>
      <p:ext uri="{BB962C8B-B14F-4D97-AF65-F5344CB8AC3E}">
        <p14:creationId xmlns:p14="http://schemas.microsoft.com/office/powerpoint/2010/main" val="1662654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20</TotalTime>
  <Words>86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2013 - 2022 Theme</vt:lpstr>
      <vt:lpstr>Prism 1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rghese, Jithu</dc:creator>
  <cp:lastModifiedBy>Joe Varghese</cp:lastModifiedBy>
  <cp:revision>30</cp:revision>
  <dcterms:created xsi:type="dcterms:W3CDTF">2022-01-27T21:50:04Z</dcterms:created>
  <dcterms:modified xsi:type="dcterms:W3CDTF">2024-10-25T11:24:02Z</dcterms:modified>
</cp:coreProperties>
</file>